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</p:sldIdLst>
  <p:sldSz cx="12192000" cy="6858000"/>
  <p:notesSz cx="6858000" cy="9144000"/>
  <p:defaultTextStyle>
    <a:defPPr>
      <a:defRPr lang="es-C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66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editar el estilo de subtítulo del patrón</a:t>
            </a:r>
            <a:endParaRPr lang="es-C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0852B6-AE4A-4C72-B831-2422F386E639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AA142-2BD8-4966-AEBE-A7A378F45383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7242865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0852B6-AE4A-4C72-B831-2422F386E639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AA142-2BD8-4966-AEBE-A7A378F45383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0061691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0852B6-AE4A-4C72-B831-2422F386E639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AA142-2BD8-4966-AEBE-A7A378F45383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9847347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0852B6-AE4A-4C72-B831-2422F386E639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AA142-2BD8-4966-AEBE-A7A378F45383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6351476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0852B6-AE4A-4C72-B831-2422F386E639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AA142-2BD8-4966-AEBE-A7A378F45383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5933812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0852B6-AE4A-4C72-B831-2422F386E639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AA142-2BD8-4966-AEBE-A7A378F45383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3729625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0852B6-AE4A-4C72-B831-2422F386E639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AA142-2BD8-4966-AEBE-A7A378F45383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5677820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0852B6-AE4A-4C72-B831-2422F386E639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AA142-2BD8-4966-AEBE-A7A378F45383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40055288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0852B6-AE4A-4C72-B831-2422F386E639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AA142-2BD8-4966-AEBE-A7A378F45383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7279795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0852B6-AE4A-4C72-B831-2422F386E639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AA142-2BD8-4966-AEBE-A7A378F45383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5584347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CL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0852B6-AE4A-4C72-B831-2422F386E639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AA142-2BD8-4966-AEBE-A7A378F45383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049072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0852B6-AE4A-4C72-B831-2422F386E639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3AA142-2BD8-4966-AEBE-A7A378F45383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2909785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C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09800" y="657225"/>
            <a:ext cx="7772400" cy="5543550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 rot="16200000">
            <a:off x="593242" y="3152071"/>
            <a:ext cx="3458815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CL" sz="2400" dirty="0"/>
              <a:t>           Log (HOMA-S </a:t>
            </a:r>
            <a:r>
              <a:rPr lang="en-US" sz="2400" dirty="0"/>
              <a:t>Index)</a:t>
            </a:r>
          </a:p>
        </p:txBody>
      </p:sp>
      <p:sp>
        <p:nvSpPr>
          <p:cNvPr id="4" name="CuadroTexto 3"/>
          <p:cNvSpPr txBox="1"/>
          <p:nvPr/>
        </p:nvSpPr>
        <p:spPr>
          <a:xfrm>
            <a:off x="5327374" y="5739110"/>
            <a:ext cx="2676940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CL" sz="2400" dirty="0"/>
              <a:t>Log (BMI (Kg/m</a:t>
            </a:r>
            <a:r>
              <a:rPr lang="es-CL" sz="2400" baseline="30000" dirty="0"/>
              <a:t>2</a:t>
            </a:r>
            <a:r>
              <a:rPr lang="es-CL" sz="2400" dirty="0"/>
              <a:t>))</a:t>
            </a:r>
          </a:p>
        </p:txBody>
      </p:sp>
      <p:sp>
        <p:nvSpPr>
          <p:cNvPr id="2" name="CuadroTexto 1"/>
          <p:cNvSpPr txBox="1"/>
          <p:nvPr/>
        </p:nvSpPr>
        <p:spPr>
          <a:xfrm>
            <a:off x="7659757" y="1007165"/>
            <a:ext cx="12192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/>
              <a:t>r= -0.21</a:t>
            </a:r>
          </a:p>
          <a:p>
            <a:r>
              <a:rPr lang="es-CL" dirty="0"/>
              <a:t>p= 0.0859</a:t>
            </a:r>
          </a:p>
        </p:txBody>
      </p:sp>
      <p:sp>
        <p:nvSpPr>
          <p:cNvPr id="6" name="CuadroTexto 5"/>
          <p:cNvSpPr txBox="1"/>
          <p:nvPr/>
        </p:nvSpPr>
        <p:spPr>
          <a:xfrm>
            <a:off x="8878957" y="6366049"/>
            <a:ext cx="30612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/>
              <a:t>Figure 1 </a:t>
            </a:r>
            <a:r>
              <a:rPr lang="es-CL" dirty="0" err="1"/>
              <a:t>supplemental</a:t>
            </a:r>
            <a:r>
              <a:rPr lang="es-CL" dirty="0"/>
              <a:t> data</a:t>
            </a:r>
          </a:p>
        </p:txBody>
      </p:sp>
    </p:spTree>
    <p:extLst>
      <p:ext uri="{BB962C8B-B14F-4D97-AF65-F5344CB8AC3E}">
        <p14:creationId xmlns:p14="http://schemas.microsoft.com/office/powerpoint/2010/main" val="2792508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35901" y="647700"/>
            <a:ext cx="7734300" cy="5562600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 rot="16200000">
            <a:off x="739016" y="3032944"/>
            <a:ext cx="3458815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CL" sz="2400" dirty="0"/>
              <a:t>          Log (Matsuda  </a:t>
            </a:r>
            <a:r>
              <a:rPr lang="en-US" sz="2400" dirty="0"/>
              <a:t>Index)</a:t>
            </a:r>
          </a:p>
        </p:txBody>
      </p:sp>
      <p:sp>
        <p:nvSpPr>
          <p:cNvPr id="4" name="CuadroTexto 3"/>
          <p:cNvSpPr txBox="1"/>
          <p:nvPr/>
        </p:nvSpPr>
        <p:spPr>
          <a:xfrm>
            <a:off x="5539409" y="5748635"/>
            <a:ext cx="2425148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CL" sz="2400" dirty="0"/>
              <a:t>Log (BMI (Kg/m</a:t>
            </a:r>
            <a:r>
              <a:rPr lang="es-CL" sz="2400" baseline="30000" dirty="0"/>
              <a:t>2</a:t>
            </a:r>
            <a:r>
              <a:rPr lang="es-CL" sz="2400" dirty="0"/>
              <a:t>))</a:t>
            </a:r>
          </a:p>
        </p:txBody>
      </p:sp>
      <p:sp>
        <p:nvSpPr>
          <p:cNvPr id="2" name="Rectángulo 1"/>
          <p:cNvSpPr/>
          <p:nvPr/>
        </p:nvSpPr>
        <p:spPr>
          <a:xfrm>
            <a:off x="7964557" y="1032514"/>
            <a:ext cx="1117614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CL" dirty="0"/>
              <a:t>r= -0.23</a:t>
            </a:r>
          </a:p>
          <a:p>
            <a:r>
              <a:rPr lang="es-CL" dirty="0"/>
              <a:t>p= 0.0653</a:t>
            </a:r>
          </a:p>
        </p:txBody>
      </p:sp>
      <p:sp>
        <p:nvSpPr>
          <p:cNvPr id="6" name="CuadroTexto 5"/>
          <p:cNvSpPr txBox="1"/>
          <p:nvPr/>
        </p:nvSpPr>
        <p:spPr>
          <a:xfrm>
            <a:off x="8878957" y="6366049"/>
            <a:ext cx="30612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/>
              <a:t>Figure 1 </a:t>
            </a:r>
            <a:r>
              <a:rPr lang="es-CL" dirty="0" err="1"/>
              <a:t>supplemental</a:t>
            </a:r>
            <a:r>
              <a:rPr lang="es-CL" dirty="0"/>
              <a:t> data</a:t>
            </a:r>
          </a:p>
        </p:txBody>
      </p:sp>
    </p:spTree>
    <p:extLst>
      <p:ext uri="{BB962C8B-B14F-4D97-AF65-F5344CB8AC3E}">
        <p14:creationId xmlns:p14="http://schemas.microsoft.com/office/powerpoint/2010/main" val="323449244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95512" y="647700"/>
            <a:ext cx="7800975" cy="5562600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 rot="16200000">
            <a:off x="627985" y="2661882"/>
            <a:ext cx="3458815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CL" sz="2400" dirty="0"/>
              <a:t>          Log (CSi </a:t>
            </a:r>
            <a:r>
              <a:rPr lang="en-US" sz="2400" dirty="0"/>
              <a:t>Index)</a:t>
            </a:r>
          </a:p>
        </p:txBody>
      </p:sp>
      <p:sp>
        <p:nvSpPr>
          <p:cNvPr id="4" name="CuadroTexto 3"/>
          <p:cNvSpPr txBox="1"/>
          <p:nvPr/>
        </p:nvSpPr>
        <p:spPr>
          <a:xfrm>
            <a:off x="5406887" y="5748635"/>
            <a:ext cx="2743200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CL" sz="2400" dirty="0"/>
              <a:t>Log (BMI (Kg/m</a:t>
            </a:r>
            <a:r>
              <a:rPr lang="es-CL" sz="2400" baseline="30000" dirty="0"/>
              <a:t>2</a:t>
            </a:r>
            <a:r>
              <a:rPr lang="es-CL" sz="2400" dirty="0"/>
              <a:t>))</a:t>
            </a:r>
          </a:p>
        </p:txBody>
      </p:sp>
      <p:sp>
        <p:nvSpPr>
          <p:cNvPr id="2" name="CuadroTexto 1"/>
          <p:cNvSpPr txBox="1"/>
          <p:nvPr/>
        </p:nvSpPr>
        <p:spPr>
          <a:xfrm>
            <a:off x="7779026" y="1163306"/>
            <a:ext cx="12192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/>
              <a:t>r= -0.23</a:t>
            </a:r>
          </a:p>
          <a:p>
            <a:r>
              <a:rPr lang="es-CL" dirty="0"/>
              <a:t>p= 0.1007</a:t>
            </a:r>
          </a:p>
        </p:txBody>
      </p:sp>
      <p:sp>
        <p:nvSpPr>
          <p:cNvPr id="6" name="CuadroTexto 5"/>
          <p:cNvSpPr txBox="1"/>
          <p:nvPr/>
        </p:nvSpPr>
        <p:spPr>
          <a:xfrm>
            <a:off x="8878957" y="6366049"/>
            <a:ext cx="30612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/>
              <a:t>Figure 1 </a:t>
            </a:r>
            <a:r>
              <a:rPr lang="es-CL" dirty="0" err="1"/>
              <a:t>supplemental</a:t>
            </a:r>
            <a:r>
              <a:rPr lang="es-CL" dirty="0"/>
              <a:t> data</a:t>
            </a:r>
          </a:p>
        </p:txBody>
      </p:sp>
    </p:spTree>
    <p:extLst>
      <p:ext uri="{BB962C8B-B14F-4D97-AF65-F5344CB8AC3E}">
        <p14:creationId xmlns:p14="http://schemas.microsoft.com/office/powerpoint/2010/main" val="250233493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9</Words>
  <Application>Microsoft Office PowerPoint</Application>
  <PresentationFormat>Panorámica</PresentationFormat>
  <Paragraphs>15</Paragraphs>
  <Slides>3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arito Bravo</dc:creator>
  <cp:lastModifiedBy>Carito Bravo</cp:lastModifiedBy>
  <cp:revision>1</cp:revision>
  <dcterms:created xsi:type="dcterms:W3CDTF">2017-03-27T14:45:37Z</dcterms:created>
  <dcterms:modified xsi:type="dcterms:W3CDTF">2017-03-27T14:45:57Z</dcterms:modified>
</cp:coreProperties>
</file>